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1104" y="3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9-May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jpeg"/><Relationship Id="rId7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/>
          <p:nvPr/>
        </p:nvGrpSpPr>
        <p:grpSpPr>
          <a:xfrm>
            <a:off x="228600" y="1424916"/>
            <a:ext cx="8686800" cy="3299484"/>
            <a:chOff x="228600" y="281916"/>
            <a:chExt cx="8686800" cy="3299484"/>
          </a:xfrm>
        </p:grpSpPr>
        <p:grpSp>
          <p:nvGrpSpPr>
            <p:cNvPr id="3" name="Group 4"/>
            <p:cNvGrpSpPr/>
            <p:nvPr/>
          </p:nvGrpSpPr>
          <p:grpSpPr>
            <a:xfrm>
              <a:off x="228600" y="281916"/>
              <a:ext cx="8686800" cy="3299484"/>
              <a:chOff x="-3962400" y="281916"/>
              <a:chExt cx="18973800" cy="6066684"/>
            </a:xfrm>
          </p:grpSpPr>
          <p:pic>
            <p:nvPicPr>
              <p:cNvPr id="2050" name="Picture 2" descr="C:\Users\ADMIN\Desktop\G2-ms-26Apr\chickpea-18-19\attachments(7)\IMG-20190203-WA0003.jpg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t="15271"/>
              <a:stretch/>
            </p:blipFill>
            <p:spPr bwMode="auto">
              <a:xfrm>
                <a:off x="5486400" y="295770"/>
                <a:ext cx="9525000" cy="605282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051" name="Picture 3" descr="C:\Users\ADMIN\Desktop\G2-ms-26Apr\chickpea-18-19\attachments(7)\IMG-20190203-WA0002.jpg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 xmlns="">
                      <a14:imgLayer r:embed="rId4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5947" t="33850" r="1893" b="3792"/>
              <a:stretch/>
            </p:blipFill>
            <p:spPr bwMode="auto">
              <a:xfrm>
                <a:off x="-3962400" y="281916"/>
                <a:ext cx="9359929" cy="606668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</p:grpSp>
        <p:pic>
          <p:nvPicPr>
            <p:cNvPr id="9" name="Picture 2" descr="C:\Users\ADMIN\Desktop\G2-ms-26Apr\chickpea-18-19\IMG-20190105-WA0001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 xmlns="">
                    <a14:imgLayer r:embed="rId6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6453" t="1854" r="51572" b="3468"/>
            <a:stretch/>
          </p:blipFill>
          <p:spPr bwMode="auto">
            <a:xfrm>
              <a:off x="3663230" y="291830"/>
              <a:ext cx="839290" cy="14035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2" descr="C:\Users\ADMIN\Desktop\G2-ms-26Apr\chickpea-18-19\IMG-20190105-WA0001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 xmlns="">
                    <a14:imgLayer r:embed="rId8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8428" t="1854" r="9596" b="3468"/>
            <a:stretch/>
          </p:blipFill>
          <p:spPr bwMode="auto">
            <a:xfrm>
              <a:off x="4570910" y="291830"/>
              <a:ext cx="839290" cy="14035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1" name="TextBox 10"/>
          <p:cNvSpPr txBox="1"/>
          <p:nvPr/>
        </p:nvSpPr>
        <p:spPr>
          <a:xfrm>
            <a:off x="275074" y="5562600"/>
            <a:ext cx="900355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. S1. Effect of TrichoBARC seed treatment on chickpea growth at Raipur (2018-19). Seeds were treated with  a  spray </a:t>
            </a:r>
          </a:p>
          <a:p>
            <a:r>
              <a:rPr lang="en-US" sz="1400" b="1" dirty="0" smtClean="0"/>
              <a:t>inoculation technique developed at IGKV, Raipur </a:t>
            </a:r>
            <a:r>
              <a:rPr lang="en-US" sz="1400" b="1" smtClean="0"/>
              <a:t>(AS </a:t>
            </a:r>
            <a:r>
              <a:rPr lang="en-US" sz="1400" b="1" dirty="0" err="1" smtClean="0"/>
              <a:t>Kotasthane</a:t>
            </a:r>
            <a:r>
              <a:rPr lang="en-US" sz="1400" b="1" dirty="0" smtClean="0"/>
              <a:t>, Unpublished)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7848600" y="1600200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TREATED</a:t>
            </a:r>
            <a:endParaRPr lang="en-US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8600" y="1600200"/>
            <a:ext cx="11072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</a:rPr>
              <a:t>CONTROL</a:t>
            </a:r>
            <a:endParaRPr lang="en-US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962201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75074" y="6248400"/>
            <a:ext cx="6819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. S2. Effect of TrichoBARC seed treatment on lentil growth at </a:t>
            </a:r>
            <a:r>
              <a:rPr lang="en-US" sz="1400" b="1" dirty="0" err="1" smtClean="0"/>
              <a:t>Mohanpur</a:t>
            </a:r>
            <a:r>
              <a:rPr lang="en-US" sz="1400" b="1" smtClean="0"/>
              <a:t> </a:t>
            </a:r>
            <a:r>
              <a:rPr lang="en-US" sz="1400" b="1" smtClean="0"/>
              <a:t> field (2018-19</a:t>
            </a:r>
            <a:r>
              <a:rPr lang="en-US" sz="1400" b="1" dirty="0" smtClean="0"/>
              <a:t>)</a:t>
            </a:r>
            <a:endParaRPr lang="en-US" sz="1400" b="1" dirty="0"/>
          </a:p>
        </p:txBody>
      </p:sp>
      <p:grpSp>
        <p:nvGrpSpPr>
          <p:cNvPr id="13" name="Group 12"/>
          <p:cNvGrpSpPr/>
          <p:nvPr/>
        </p:nvGrpSpPr>
        <p:grpSpPr>
          <a:xfrm>
            <a:off x="76201" y="381000"/>
            <a:ext cx="8458200" cy="5715001"/>
            <a:chOff x="76201" y="381000"/>
            <a:chExt cx="8458200" cy="5715001"/>
          </a:xfrm>
        </p:grpSpPr>
        <p:grpSp>
          <p:nvGrpSpPr>
            <p:cNvPr id="8" name="Group 7"/>
            <p:cNvGrpSpPr/>
            <p:nvPr/>
          </p:nvGrpSpPr>
          <p:grpSpPr>
            <a:xfrm>
              <a:off x="76201" y="381000"/>
              <a:ext cx="8458200" cy="5715001"/>
              <a:chOff x="76200" y="134112"/>
              <a:chExt cx="8949503" cy="6172201"/>
            </a:xfrm>
          </p:grpSpPr>
          <p:pic>
            <p:nvPicPr>
              <p:cNvPr id="61442" name="Picture 2" descr="C:\Users\admin\Desktop\lentil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r="-1550"/>
              <a:stretch>
                <a:fillRect/>
              </a:stretch>
            </p:blipFill>
            <p:spPr bwMode="auto">
              <a:xfrm>
                <a:off x="76200" y="134112"/>
                <a:ext cx="4991100" cy="6172200"/>
              </a:xfrm>
              <a:prstGeom prst="rect">
                <a:avLst/>
              </a:prstGeom>
              <a:noFill/>
            </p:spPr>
          </p:pic>
          <p:pic>
            <p:nvPicPr>
              <p:cNvPr id="4" name="Picture 3" descr="C:\Users\admin\Desktop\G2-paper\BCKV-lentil\IMG_20190113_121810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/>
              </a:blip>
              <a:srcRect t="13169"/>
              <a:stretch>
                <a:fillRect/>
              </a:stretch>
            </p:blipFill>
            <p:spPr bwMode="auto">
              <a:xfrm rot="16200000">
                <a:off x="3979452" y="1260062"/>
                <a:ext cx="6172200" cy="3920302"/>
              </a:xfrm>
              <a:prstGeom prst="rect">
                <a:avLst/>
              </a:prstGeom>
              <a:noFill/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3505200" y="1611217"/>
              <a:ext cx="10310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TREATED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581400" y="4724400"/>
              <a:ext cx="11072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CONTROL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239000" y="1676400"/>
              <a:ext cx="103105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TREATED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315200" y="4800600"/>
              <a:ext cx="11072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CONTROL</a:t>
              </a:r>
              <a:endParaRPr lang="en-US" b="1" dirty="0">
                <a:solidFill>
                  <a:schemeClr val="bg1"/>
                </a:solidFill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60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16</cp:revision>
  <dcterms:created xsi:type="dcterms:W3CDTF">2006-08-16T00:00:00Z</dcterms:created>
  <dcterms:modified xsi:type="dcterms:W3CDTF">2019-05-29T07:05:49Z</dcterms:modified>
</cp:coreProperties>
</file>